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7" r:id="rId2"/>
  </p:sldIdLst>
  <p:sldSz cx="17610138" cy="990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无样式，无网格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436"/>
    <p:restoredTop sz="95748"/>
  </p:normalViewPr>
  <p:slideViewPr>
    <p:cSldViewPr snapToGrid="0" snapToObjects="1">
      <p:cViewPr varScale="1">
        <p:scale>
          <a:sx n="77" d="100"/>
          <a:sy n="77" d="100"/>
        </p:scale>
        <p:origin x="61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201267" y="1621191"/>
            <a:ext cx="13207604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01267" y="5202944"/>
            <a:ext cx="13207604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B607A7-567B-544D-AAD8-B78A3D991E38}" type="datetimeFigureOut">
              <a:rPr kumimoji="1" lang="zh-CN" altLang="en-US" smtClean="0"/>
              <a:t>2021/12/1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5E4E1-08F5-3542-9CAA-12D6A67E038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5137012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B607A7-567B-544D-AAD8-B78A3D991E38}" type="datetimeFigureOut">
              <a:rPr kumimoji="1" lang="zh-CN" altLang="en-US" smtClean="0"/>
              <a:t>2021/12/1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5E4E1-08F5-3542-9CAA-12D6A67E038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051307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602255" y="527403"/>
            <a:ext cx="379718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10697" y="527403"/>
            <a:ext cx="11171431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B607A7-567B-544D-AAD8-B78A3D991E38}" type="datetimeFigureOut">
              <a:rPr kumimoji="1" lang="zh-CN" altLang="en-US" smtClean="0"/>
              <a:t>2021/12/1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5E4E1-08F5-3542-9CAA-12D6A67E038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1123629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B607A7-567B-544D-AAD8-B78A3D991E38}" type="datetimeFigureOut">
              <a:rPr kumimoji="1" lang="zh-CN" altLang="en-US" smtClean="0"/>
              <a:t>2021/12/1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5E4E1-08F5-3542-9CAA-12D6A67E038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3806522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01525" y="2469622"/>
            <a:ext cx="15188744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01525" y="6629225"/>
            <a:ext cx="15188744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>
                    <a:tint val="75000"/>
                  </a:schemeClr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B607A7-567B-544D-AAD8-B78A3D991E38}" type="datetimeFigureOut">
              <a:rPr kumimoji="1" lang="zh-CN" altLang="en-US" smtClean="0"/>
              <a:t>2021/12/1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5E4E1-08F5-3542-9CAA-12D6A67E038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3033033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10697" y="2637014"/>
            <a:ext cx="7484309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915132" y="2637014"/>
            <a:ext cx="7484309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B607A7-567B-544D-AAD8-B78A3D991E38}" type="datetimeFigureOut">
              <a:rPr kumimoji="1" lang="zh-CN" altLang="en-US" smtClean="0"/>
              <a:t>2021/12/16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5E4E1-08F5-3542-9CAA-12D6A67E038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6147196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12991" y="527404"/>
            <a:ext cx="15188744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12991" y="2428347"/>
            <a:ext cx="7449913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12991" y="3618442"/>
            <a:ext cx="744991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915133" y="2428347"/>
            <a:ext cx="7486602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915133" y="3618442"/>
            <a:ext cx="7486602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B607A7-567B-544D-AAD8-B78A3D991E38}" type="datetimeFigureOut">
              <a:rPr kumimoji="1" lang="zh-CN" altLang="en-US" smtClean="0"/>
              <a:t>2021/12/16</a:t>
            </a:fld>
            <a:endParaRPr kumimoji="1"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5E4E1-08F5-3542-9CAA-12D6A67E038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3761187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B607A7-567B-544D-AAD8-B78A3D991E38}" type="datetimeFigureOut">
              <a:rPr kumimoji="1" lang="zh-CN" altLang="en-US" smtClean="0"/>
              <a:t>2021/12/16</a:t>
            </a:fld>
            <a:endParaRPr kumimoji="1"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5E4E1-08F5-3542-9CAA-12D6A67E038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2455200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B607A7-567B-544D-AAD8-B78A3D991E38}" type="datetimeFigureOut">
              <a:rPr kumimoji="1" lang="zh-CN" altLang="en-US" smtClean="0"/>
              <a:t>2021/12/16</a:t>
            </a:fld>
            <a:endParaRPr kumimoji="1"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5E4E1-08F5-3542-9CAA-12D6A67E038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35496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12992" y="660400"/>
            <a:ext cx="5679727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486603" y="1426281"/>
            <a:ext cx="8915132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12992" y="2971800"/>
            <a:ext cx="5679727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B607A7-567B-544D-AAD8-B78A3D991E38}" type="datetimeFigureOut">
              <a:rPr kumimoji="1" lang="zh-CN" altLang="en-US" smtClean="0"/>
              <a:t>2021/12/16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5E4E1-08F5-3542-9CAA-12D6A67E038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0322102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12992" y="660400"/>
            <a:ext cx="5679727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486603" y="1426281"/>
            <a:ext cx="8915132" cy="7039681"/>
          </a:xfrm>
        </p:spPr>
        <p:txBody>
          <a:bodyPr anchor="t"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12992" y="2971800"/>
            <a:ext cx="5679727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B607A7-567B-544D-AAD8-B78A3D991E38}" type="datetimeFigureOut">
              <a:rPr kumimoji="1" lang="zh-CN" altLang="en-US" smtClean="0"/>
              <a:t>2021/12/16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5E4E1-08F5-3542-9CAA-12D6A67E038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9698838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10697" y="527404"/>
            <a:ext cx="15188744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10697" y="2637014"/>
            <a:ext cx="15188744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10697" y="9181395"/>
            <a:ext cx="3962281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B607A7-567B-544D-AAD8-B78A3D991E38}" type="datetimeFigureOut">
              <a:rPr kumimoji="1" lang="zh-CN" altLang="en-US" smtClean="0"/>
              <a:t>2021/12/1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833358" y="9181395"/>
            <a:ext cx="5943422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437160" y="9181395"/>
            <a:ext cx="3962281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E5E4E1-08F5-3542-9CAA-12D6A67E038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7979766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320759" rtl="0" eaLnBrk="1" latinLnBrk="0" hangingPunct="1">
        <a:lnSpc>
          <a:spcPct val="90000"/>
        </a:lnSpc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0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>
            <a:extLst>
              <a:ext uri="{FF2B5EF4-FFF2-40B4-BE49-F238E27FC236}">
                <a16:creationId xmlns:a16="http://schemas.microsoft.com/office/drawing/2014/main" id="{F955662C-7C5C-9843-A86F-57D235F15C3B}"/>
              </a:ext>
            </a:extLst>
          </p:cNvPr>
          <p:cNvSpPr/>
          <p:nvPr/>
        </p:nvSpPr>
        <p:spPr>
          <a:xfrm>
            <a:off x="4947557" y="816428"/>
            <a:ext cx="6386512" cy="129082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 algn="ctr" defTabSz="685800">
              <a:lnSpc>
                <a:spcPct val="90000"/>
              </a:lnSpc>
              <a:spcBef>
                <a:spcPct val="0"/>
              </a:spcBef>
              <a:spcAft>
                <a:spcPts val="600"/>
              </a:spcAft>
            </a:pPr>
            <a:r>
              <a:rPr kumimoji="1" lang="en-US" altLang="zh-CN" dirty="0"/>
              <a:t>Supplementary </a:t>
            </a:r>
            <a:r>
              <a:rPr lang="en-US" altLang="zh-CN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Table S2. Information of primary antibodies. </a:t>
            </a:r>
          </a:p>
        </p:txBody>
      </p:sp>
      <p:graphicFrame>
        <p:nvGraphicFramePr>
          <p:cNvPr id="3" name="表格 2">
            <a:extLst>
              <a:ext uri="{FF2B5EF4-FFF2-40B4-BE49-F238E27FC236}">
                <a16:creationId xmlns:a16="http://schemas.microsoft.com/office/drawing/2014/main" id="{73328A62-8234-214A-9921-372FD00B5CC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34846910"/>
              </p:ext>
            </p:extLst>
          </p:nvPr>
        </p:nvGraphicFramePr>
        <p:xfrm>
          <a:off x="5237572" y="1660722"/>
          <a:ext cx="7134993" cy="6035843"/>
        </p:xfrm>
        <a:graphic>
          <a:graphicData uri="http://schemas.openxmlformats.org/drawingml/2006/table">
            <a:tbl>
              <a:tblPr firstRow="1" firstCol="1" bandRow="1"/>
              <a:tblGrid>
                <a:gridCol w="2169247">
                  <a:extLst>
                    <a:ext uri="{9D8B030D-6E8A-4147-A177-3AD203B41FA5}">
                      <a16:colId xmlns:a16="http://schemas.microsoft.com/office/drawing/2014/main" val="3672008949"/>
                    </a:ext>
                  </a:extLst>
                </a:gridCol>
                <a:gridCol w="2822635">
                  <a:extLst>
                    <a:ext uri="{9D8B030D-6E8A-4147-A177-3AD203B41FA5}">
                      <a16:colId xmlns:a16="http://schemas.microsoft.com/office/drawing/2014/main" val="2807067569"/>
                    </a:ext>
                  </a:extLst>
                </a:gridCol>
                <a:gridCol w="2143111">
                  <a:extLst>
                    <a:ext uri="{9D8B030D-6E8A-4147-A177-3AD203B41FA5}">
                      <a16:colId xmlns:a16="http://schemas.microsoft.com/office/drawing/2014/main" val="394570793"/>
                    </a:ext>
                  </a:extLst>
                </a:gridCol>
              </a:tblGrid>
              <a:tr h="548713"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i="0" u="none" strike="noStrike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antibody</a:t>
                      </a:r>
                      <a:endParaRPr lang="en-US" altLang="zh-CN" sz="31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16739" marR="116739" marT="1621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i="0" u="none" strike="noStrike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manufacturer</a:t>
                      </a:r>
                      <a:endParaRPr lang="en-US" altLang="zh-CN" sz="31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16739" marR="116739" marT="1621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i="0" u="none" strike="noStrike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catalogue</a:t>
                      </a:r>
                      <a:endParaRPr lang="en-US" altLang="zh-CN" sz="31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16739" marR="116739" marT="1621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57294799"/>
                  </a:ext>
                </a:extLst>
              </a:tr>
              <a:tr h="548713"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i="0" u="none" strike="noStrike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IL-6</a:t>
                      </a:r>
                      <a:endParaRPr lang="en-US" altLang="zh-CN" sz="31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16739" marR="116739" marT="1621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i="0" u="none" strike="noStrike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CST</a:t>
                      </a:r>
                      <a:endParaRPr lang="en-US" altLang="zh-CN" sz="31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16739" marR="116739" marT="1621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i="0" u="none" strike="noStrike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12153S</a:t>
                      </a:r>
                      <a:endParaRPr lang="en-US" altLang="zh-CN" sz="31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16739" marR="116739" marT="1621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04786879"/>
                  </a:ext>
                </a:extLst>
              </a:tr>
              <a:tr h="548713"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i="0" u="none" strike="noStrike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Aggrecan</a:t>
                      </a:r>
                      <a:endParaRPr lang="en-US" altLang="zh-CN" sz="31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16739" marR="116739" marT="162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i="0" u="none" strike="noStrike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Invitrogen</a:t>
                      </a:r>
                      <a:endParaRPr lang="en-US" altLang="zh-CN" sz="31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16739" marR="116739" marT="162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i="0" u="none" strike="noStrike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MA3-16888</a:t>
                      </a:r>
                      <a:endParaRPr lang="en-US" altLang="zh-CN" sz="31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16739" marR="116739" marT="162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23772502"/>
                  </a:ext>
                </a:extLst>
              </a:tr>
              <a:tr h="548713"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i="0" u="none" strike="noStrike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Collegan II</a:t>
                      </a:r>
                      <a:endParaRPr lang="en-US" altLang="zh-CN" sz="31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16739" marR="116739" marT="162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i="0" u="none" strike="noStrike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Invitrogen</a:t>
                      </a:r>
                      <a:endParaRPr lang="en-US" altLang="zh-CN" sz="31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16739" marR="116739" marT="162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i="0" u="none" strike="noStrike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MA5-12789</a:t>
                      </a:r>
                      <a:endParaRPr lang="en-US" altLang="zh-CN" sz="31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16739" marR="116739" marT="162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31977870"/>
                  </a:ext>
                </a:extLst>
              </a:tr>
              <a:tr h="548713"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i="0" u="none" strike="noStrike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Adamts4</a:t>
                      </a:r>
                      <a:endParaRPr lang="en-US" altLang="zh-CN" sz="31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16739" marR="116739" marT="162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i="0" u="none" strike="noStrike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Abcam</a:t>
                      </a:r>
                      <a:endParaRPr lang="en-US" altLang="zh-CN" sz="31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16739" marR="116739" marT="162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i="0" u="none" strike="noStrike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ab185722</a:t>
                      </a:r>
                      <a:endParaRPr lang="en-US" altLang="zh-CN" sz="31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16739" marR="116739" marT="162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43305364"/>
                  </a:ext>
                </a:extLst>
              </a:tr>
              <a:tr h="548713"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i="0" u="none" strike="noStrike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ADAMTS5</a:t>
                      </a:r>
                      <a:endParaRPr lang="en-US" altLang="zh-CN" sz="31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16739" marR="116739" marT="162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i="0" u="none" strike="noStrike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Abcam</a:t>
                      </a:r>
                      <a:endParaRPr lang="en-US" altLang="zh-CN" sz="31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16739" marR="116739" marT="162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i="0" u="none" strike="noStrike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ab41037</a:t>
                      </a:r>
                      <a:endParaRPr lang="en-US" altLang="zh-CN" sz="31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16739" marR="116739" marT="162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89221624"/>
                  </a:ext>
                </a:extLst>
              </a:tr>
              <a:tr h="548713"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i="0" u="none" strike="noStrike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P65</a:t>
                      </a:r>
                      <a:endParaRPr lang="en-US" altLang="zh-CN" sz="31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16739" marR="116739" marT="162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i="0" u="none" strike="noStrike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CST</a:t>
                      </a:r>
                      <a:endParaRPr lang="en-US" altLang="zh-CN" sz="31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16739" marR="116739" marT="162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i="0" u="none" strike="noStrike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4764</a:t>
                      </a:r>
                      <a:endParaRPr lang="en-US" altLang="zh-CN" sz="31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16739" marR="116739" marT="162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36427906"/>
                  </a:ext>
                </a:extLst>
              </a:tr>
              <a:tr h="548713"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i="0" u="none" strike="noStrike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p-P65</a:t>
                      </a:r>
                      <a:endParaRPr lang="en-US" altLang="zh-CN" sz="31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16739" marR="116739" marT="162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i="0" u="none" strike="noStrike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CST</a:t>
                      </a:r>
                      <a:endParaRPr lang="en-US" altLang="zh-CN" sz="31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16739" marR="116739" marT="162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i="0" u="none" strike="noStrike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3033</a:t>
                      </a:r>
                      <a:endParaRPr lang="en-US" altLang="zh-CN" sz="31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16739" marR="116739" marT="162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80090616"/>
                  </a:ext>
                </a:extLst>
              </a:tr>
              <a:tr h="548713"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i="0" u="none" strike="noStrike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P21</a:t>
                      </a:r>
                      <a:endParaRPr lang="en-US" altLang="zh-CN" sz="31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16739" marR="116739" marT="162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i="0" u="none" strike="noStrike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Proteintech</a:t>
                      </a:r>
                      <a:endParaRPr lang="en-US" altLang="zh-CN" sz="31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16739" marR="116739" marT="162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i="0" u="none" strike="noStrike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10355-1-AP</a:t>
                      </a:r>
                      <a:endParaRPr lang="en-US" altLang="zh-CN" sz="31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16739" marR="116739" marT="162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78458292"/>
                  </a:ext>
                </a:extLst>
              </a:tr>
              <a:tr h="548713"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i="0" u="none" strike="noStrike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GAPDH</a:t>
                      </a:r>
                      <a:endParaRPr lang="en-US" altLang="zh-CN" sz="31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16739" marR="116739" marT="162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i="0" u="none" strike="noStrike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Proteintech</a:t>
                      </a:r>
                      <a:endParaRPr lang="en-US" altLang="zh-CN" sz="31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16739" marR="116739" marT="162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i="0" u="none" strike="noStrike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60004-1-Ig</a:t>
                      </a:r>
                      <a:endParaRPr lang="en-US" altLang="zh-CN" sz="31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16739" marR="116739" marT="162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03689170"/>
                  </a:ext>
                </a:extLst>
              </a:tr>
              <a:tr h="548713"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l-GR" altLang="zh-CN" sz="1800" b="0" i="0" u="none" strike="noStrike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β</a:t>
                      </a:r>
                      <a:r>
                        <a:rPr lang="el-GR" sz="1800" b="0" i="0" u="none" strike="noStrike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r>
                        <a:rPr lang="en-US" sz="1800" b="0" i="0" u="none" strike="noStrike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ACTIN</a:t>
                      </a:r>
                      <a:endParaRPr lang="en-US" altLang="zh-CN" sz="31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16739" marR="116739" marT="162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i="0" u="none" strike="noStrike" kern="1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Proteintech</a:t>
                      </a:r>
                      <a:endParaRPr lang="en-US" altLang="zh-CN" sz="31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16739" marR="116739" marT="162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i="0" u="none" strike="noStrike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66009-1-Ig</a:t>
                      </a:r>
                      <a:endParaRPr lang="en-US" altLang="zh-CN" sz="31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16739" marR="116739" marT="162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12426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7562028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77</TotalTime>
  <Words>44</Words>
  <Application>Microsoft Macintosh PowerPoint</Application>
  <PresentationFormat>自定义</PresentationFormat>
  <Paragraphs>3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tyzs</dc:creator>
  <cp:lastModifiedBy>tyzs</cp:lastModifiedBy>
  <cp:revision>17</cp:revision>
  <dcterms:created xsi:type="dcterms:W3CDTF">2021-10-08T02:21:38Z</dcterms:created>
  <dcterms:modified xsi:type="dcterms:W3CDTF">2021-12-16T10:18:54Z</dcterms:modified>
</cp:coreProperties>
</file>